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111601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66" d="100"/>
          <a:sy n="66" d="100"/>
        </p:scale>
        <p:origin x="668" y="-16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kereny\Dropbox%20(Weizmann%20Institute)\Paper%203%20May%202019\September%202019\Differential%20OTUs\Final\Taxonomy\Summary%20taxa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kereny\Dropbox%20(Weizmann%20Institute)\Paper%203%20May%202019\September%202019\Differential%20OTUs\Final\Taxonomy\Summary%20taxa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Users\kereny\Dropbox%20(Weizmann%20Institute)\Paper%203%20May%202019\September%202019\Differential%20OTUs\Final\Taxonomy\Summary%20taxa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reny\Dropbox%20(Weizmann%20Institute)\Paper%203%20May%202019\September%202019\Differential%20OTUs\Final\Taxonomy\Summary%20taxa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reny\Dropbox%20(Weizmann%20Institute)\Paper%203%20May%202019\September%202019\Differential%20OTUs\Final\Taxonomy\Summary%20taxa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reny\Dropbox%20(Weizmann%20Institute)\Paper%203%20May%202019\September%202019\Differential%20OTUs\Final\Taxonomy\Summary%20taxa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renyg\Dropbox%20(Weizmann%20Institute)\Paper%203%20May%202019\September%202019\Differential%20OTUs\Final\Taxonomy\Summary%20taxa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kereny\Dropbox%20(Weizmann%20Institute)\Paper%203%20May%202019\September%202019\Differential%20OTUs\Final\Taxonomy\Summary%20taxa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Rhodospirillacea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1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e-IL"/>
        </a:p>
      </c:txPr>
    </c:title>
    <c:autoTitleDeleted val="0"/>
    <c:plotArea>
      <c:layout>
        <c:manualLayout>
          <c:layoutTarget val="inner"/>
          <c:xMode val="edge"/>
          <c:yMode val="edge"/>
          <c:x val="0.18930666666666671"/>
          <c:y val="0.20222350427350427"/>
          <c:w val="0.77188777777777773"/>
          <c:h val="0.6094200854700854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16S+SGM'!$A$10</c:f>
              <c:strCache>
                <c:ptCount val="1"/>
                <c:pt idx="0">
                  <c:v>16S amplicon-seq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ummary 16S+SGM'!$B$1:$G$1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Summary 16S+SGM'!$B$10:$G$10</c:f>
              <c:numCache>
                <c:formatCode>0.00%</c:formatCode>
                <c:ptCount val="6"/>
                <c:pt idx="0">
                  <c:v>0</c:v>
                </c:pt>
                <c:pt idx="1">
                  <c:v>0</c:v>
                </c:pt>
                <c:pt idx="2">
                  <c:v>5.3900709219779994E-3</c:v>
                </c:pt>
                <c:pt idx="3">
                  <c:v>0.05</c:v>
                </c:pt>
                <c:pt idx="4">
                  <c:v>8.3687943262464003E-3</c:v>
                </c:pt>
                <c:pt idx="5">
                  <c:v>5.806737588665499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B3-4ADA-AC05-4CF32A671BA9}"/>
            </c:ext>
          </c:extLst>
        </c:ser>
        <c:ser>
          <c:idx val="1"/>
          <c:order val="1"/>
          <c:tx>
            <c:strRef>
              <c:f>'Summary 16S+SGM'!$A$11</c:f>
              <c:strCache>
                <c:ptCount val="1"/>
                <c:pt idx="0">
                  <c:v>SGM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'Summary 16S+SGM'!$B$1:$G$1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Summary 16S+SGM'!$B$11:$G$11</c:f>
              <c:numCache>
                <c:formatCode>0.00%</c:formatCode>
                <c:ptCount val="6"/>
                <c:pt idx="0">
                  <c:v>4.6339863342449977E-3</c:v>
                </c:pt>
                <c:pt idx="1">
                  <c:v>1.88619687579571E-3</c:v>
                </c:pt>
                <c:pt idx="2">
                  <c:v>3.544333665340231E-3</c:v>
                </c:pt>
                <c:pt idx="3">
                  <c:v>1.8004376499610134E-2</c:v>
                </c:pt>
                <c:pt idx="4">
                  <c:v>3.9053706699333536E-3</c:v>
                </c:pt>
                <c:pt idx="5">
                  <c:v>2.5109536379427366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6B3-4ADA-AC05-4CF32A671B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93435504"/>
        <c:axId val="1093433536"/>
      </c:barChart>
      <c:catAx>
        <c:axId val="1093435504"/>
        <c:scaling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crossAx val="1093433536"/>
        <c:crosses val="autoZero"/>
        <c:auto val="1"/>
        <c:lblAlgn val="ctr"/>
        <c:lblOffset val="100"/>
        <c:noMultiLvlLbl val="0"/>
      </c:catAx>
      <c:valAx>
        <c:axId val="1093433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Relative abundanc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he-IL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e-IL"/>
          </a:p>
        </c:txPr>
        <c:crossAx val="1093435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ysClr val="windowText" lastClr="000000"/>
      </a:solidFill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he-IL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Rhodocyclacea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1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e-IL"/>
        </a:p>
      </c:txPr>
    </c:title>
    <c:autoTitleDeleted val="0"/>
    <c:plotArea>
      <c:layout>
        <c:manualLayout>
          <c:layoutTarget val="inner"/>
          <c:xMode val="edge"/>
          <c:yMode val="edge"/>
          <c:x val="0.22343805555555554"/>
          <c:y val="0.20222350427350427"/>
          <c:w val="0.72364527777777776"/>
          <c:h val="0.6257021367521367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16S+SGM'!$A$13</c:f>
              <c:strCache>
                <c:ptCount val="1"/>
                <c:pt idx="0">
                  <c:v>16S amplicon-seq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ummary 16S+SGM'!$B$1:$G$1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Summary 16S+SGM'!$B$13:$G$13</c:f>
              <c:numCache>
                <c:formatCode>0.00%</c:formatCode>
                <c:ptCount val="6"/>
                <c:pt idx="0">
                  <c:v>0.26312056737587802</c:v>
                </c:pt>
                <c:pt idx="1">
                  <c:v>0.11713947990544067</c:v>
                </c:pt>
                <c:pt idx="2">
                  <c:v>6.5177304964548405E-2</c:v>
                </c:pt>
                <c:pt idx="3">
                  <c:v>6.0283687943280002E-3</c:v>
                </c:pt>
                <c:pt idx="4">
                  <c:v>4.2836879432622002E-2</c:v>
                </c:pt>
                <c:pt idx="5">
                  <c:v>2.34929078014099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D9-43CB-AC23-2F9CB93F9AE9}"/>
            </c:ext>
          </c:extLst>
        </c:ser>
        <c:ser>
          <c:idx val="1"/>
          <c:order val="1"/>
          <c:tx>
            <c:strRef>
              <c:f>'Summary 16S+SGM'!$A$14</c:f>
              <c:strCache>
                <c:ptCount val="1"/>
                <c:pt idx="0">
                  <c:v>SGM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'Summary 16S+SGM'!$B$1:$G$1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Summary 16S+SGM'!$B$14:$G$14</c:f>
              <c:numCache>
                <c:formatCode>0.00%</c:formatCode>
                <c:ptCount val="6"/>
                <c:pt idx="0">
                  <c:v>0.23491314484916742</c:v>
                </c:pt>
                <c:pt idx="1">
                  <c:v>0.1743518105387582</c:v>
                </c:pt>
                <c:pt idx="2">
                  <c:v>4.3817632484651224E-2</c:v>
                </c:pt>
                <c:pt idx="3">
                  <c:v>5.5538768889475312E-3</c:v>
                </c:pt>
                <c:pt idx="4">
                  <c:v>2.0834112523917411E-2</c:v>
                </c:pt>
                <c:pt idx="5">
                  <c:v>1.084443987265312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8D9-43CB-AC23-2F9CB93F9A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93435504"/>
        <c:axId val="1093433536"/>
      </c:barChart>
      <c:catAx>
        <c:axId val="1093435504"/>
        <c:scaling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crossAx val="1093433536"/>
        <c:crosses val="autoZero"/>
        <c:auto val="1"/>
        <c:lblAlgn val="ctr"/>
        <c:lblOffset val="100"/>
        <c:noMultiLvlLbl val="0"/>
      </c:catAx>
      <c:valAx>
        <c:axId val="1093433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Relative abundanc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he-IL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e-IL"/>
          </a:p>
        </c:txPr>
        <c:crossAx val="1093435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ysClr val="windowText" lastClr="000000"/>
      </a:solidFill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he-IL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 dirty="0" err="1" smtClean="0"/>
              <a:t>Ruminococcaceae</a:t>
            </a:r>
            <a:endParaRPr lang="en-US" i="1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1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e-IL"/>
        </a:p>
      </c:txPr>
    </c:title>
    <c:autoTitleDeleted val="0"/>
    <c:plotArea>
      <c:layout>
        <c:manualLayout>
          <c:layoutTarget val="inner"/>
          <c:xMode val="edge"/>
          <c:yMode val="edge"/>
          <c:x val="0.18930666666666671"/>
          <c:y val="0.20222350427350427"/>
          <c:w val="0.77188777777777773"/>
          <c:h val="0.6094200854700854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16S+SGM'!$A$16</c:f>
              <c:strCache>
                <c:ptCount val="1"/>
                <c:pt idx="0">
                  <c:v>16S amplicon-seq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'Summary 16S+SGM'!$B$1:$G$1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Summary 16S+SGM'!$B$16:$G$16</c:f>
              <c:numCache>
                <c:formatCode>0.00%</c:formatCode>
                <c:ptCount val="6"/>
                <c:pt idx="0">
                  <c:v>3.5460992907800001E-4</c:v>
                </c:pt>
                <c:pt idx="1">
                  <c:v>5.9101654846199997E-4</c:v>
                </c:pt>
                <c:pt idx="2">
                  <c:v>1.0141843971628799E-2</c:v>
                </c:pt>
                <c:pt idx="3">
                  <c:v>1.8085106382990001E-2</c:v>
                </c:pt>
                <c:pt idx="4">
                  <c:v>4.9645390070891995E-3</c:v>
                </c:pt>
                <c:pt idx="5">
                  <c:v>3.280141843969500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475-435E-8E3F-2C41F5E72E70}"/>
            </c:ext>
          </c:extLst>
        </c:ser>
        <c:ser>
          <c:idx val="1"/>
          <c:order val="1"/>
          <c:tx>
            <c:strRef>
              <c:f>'Summary 16S+SGM'!$A$17</c:f>
              <c:strCache>
                <c:ptCount val="1"/>
                <c:pt idx="0">
                  <c:v>SGM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'Summary 16S+SGM'!$B$1:$G$1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Summary 16S+SGM'!$B$17:$G$17</c:f>
              <c:numCache>
                <c:formatCode>0.00%</c:formatCode>
                <c:ptCount val="6"/>
                <c:pt idx="0">
                  <c:v>5.0121661397034513E-4</c:v>
                </c:pt>
                <c:pt idx="1">
                  <c:v>1.3992809704796085E-3</c:v>
                </c:pt>
                <c:pt idx="2">
                  <c:v>1.04925640875098E-3</c:v>
                </c:pt>
                <c:pt idx="3">
                  <c:v>2.5741097642298233E-3</c:v>
                </c:pt>
                <c:pt idx="4">
                  <c:v>8.9071940433625403E-4</c:v>
                </c:pt>
                <c:pt idx="5">
                  <c:v>9.5097432850892367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475-435E-8E3F-2C41F5E72E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93435504"/>
        <c:axId val="1093433536"/>
      </c:barChart>
      <c:catAx>
        <c:axId val="1093435504"/>
        <c:scaling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crossAx val="1093433536"/>
        <c:crosses val="autoZero"/>
        <c:auto val="1"/>
        <c:lblAlgn val="ctr"/>
        <c:lblOffset val="100"/>
        <c:noMultiLvlLbl val="0"/>
      </c:catAx>
      <c:valAx>
        <c:axId val="1093433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Relative abundanc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he-IL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e-IL"/>
          </a:p>
        </c:txPr>
        <c:crossAx val="1093435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ysClr val="windowText" lastClr="000000"/>
      </a:solidFill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he-IL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Porphyromonadacea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1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e-IL"/>
        </a:p>
      </c:txPr>
    </c:title>
    <c:autoTitleDeleted val="0"/>
    <c:plotArea>
      <c:layout>
        <c:manualLayout>
          <c:layoutTarget val="inner"/>
          <c:xMode val="edge"/>
          <c:yMode val="edge"/>
          <c:x val="0.20579916666666667"/>
          <c:y val="0.20222350427350427"/>
          <c:w val="0.75539527777777782"/>
          <c:h val="0.5714286324786325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16S+SGM'!$A$20</c:f>
              <c:strCache>
                <c:ptCount val="1"/>
                <c:pt idx="0">
                  <c:v>16S amplicon-seq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ummary 16S+SGM'!$B$1:$G$1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Summary 16S+SGM'!$B$20:$G$20</c:f>
              <c:numCache>
                <c:formatCode>0.00%</c:formatCode>
                <c:ptCount val="6"/>
                <c:pt idx="0">
                  <c:v>5.2836879432603998E-2</c:v>
                </c:pt>
                <c:pt idx="1">
                  <c:v>0.12086288416074735</c:v>
                </c:pt>
                <c:pt idx="2">
                  <c:v>0.165319148936352</c:v>
                </c:pt>
                <c:pt idx="3">
                  <c:v>0.21063829787263602</c:v>
                </c:pt>
                <c:pt idx="4">
                  <c:v>9.5886524822752006E-2</c:v>
                </c:pt>
                <c:pt idx="5">
                  <c:v>3.2978723404263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46-41C0-8C29-D1D25A4A36F4}"/>
            </c:ext>
          </c:extLst>
        </c:ser>
        <c:ser>
          <c:idx val="1"/>
          <c:order val="1"/>
          <c:tx>
            <c:strRef>
              <c:f>'Summary 16S+SGM'!$A$21</c:f>
              <c:strCache>
                <c:ptCount val="1"/>
                <c:pt idx="0">
                  <c:v>SGM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'Summary 16S+SGM'!$B$1:$G$1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Summary 16S+SGM'!$B$21:$G$21</c:f>
              <c:numCache>
                <c:formatCode>0.00%</c:formatCode>
                <c:ptCount val="6"/>
                <c:pt idx="0">
                  <c:v>1.364348167493442E-2</c:v>
                </c:pt>
                <c:pt idx="1">
                  <c:v>4.3998947619236721E-2</c:v>
                </c:pt>
                <c:pt idx="2">
                  <c:v>4.3881820331285515E-2</c:v>
                </c:pt>
                <c:pt idx="3">
                  <c:v>8.5960764098435463E-2</c:v>
                </c:pt>
                <c:pt idx="4">
                  <c:v>1.474020800974998E-2</c:v>
                </c:pt>
                <c:pt idx="5">
                  <c:v>1.538146919104673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246-41C0-8C29-D1D25A4A36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93435504"/>
        <c:axId val="1093433536"/>
      </c:barChart>
      <c:catAx>
        <c:axId val="1093435504"/>
        <c:scaling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crossAx val="1093433536"/>
        <c:crosses val="autoZero"/>
        <c:auto val="1"/>
        <c:lblAlgn val="ctr"/>
        <c:lblOffset val="100"/>
        <c:noMultiLvlLbl val="0"/>
      </c:catAx>
      <c:valAx>
        <c:axId val="1093433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Relative abundanc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he-IL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e-IL"/>
          </a:p>
        </c:txPr>
        <c:crossAx val="1093435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he-IL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 dirty="0" err="1"/>
              <a:t>Flavobacteriia</a:t>
            </a:r>
            <a:endParaRPr lang="en-US" i="1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1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e-IL"/>
        </a:p>
      </c:txPr>
    </c:title>
    <c:autoTitleDeleted val="0"/>
    <c:plotArea>
      <c:layout>
        <c:manualLayout>
          <c:layoutTarget val="inner"/>
          <c:xMode val="edge"/>
          <c:yMode val="edge"/>
          <c:x val="0.20227138888888888"/>
          <c:y val="0.20222350427350427"/>
          <c:w val="0.7659786111111111"/>
          <c:h val="0.6094200854700854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16S+SGM'!$A$2</c:f>
              <c:strCache>
                <c:ptCount val="1"/>
                <c:pt idx="0">
                  <c:v>16S amplicon-seq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ummary 16S+SGM'!$B$1:$G$1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Summary 16S+SGM'!$B$2:$G$2</c:f>
              <c:numCache>
                <c:formatCode>0.00%</c:formatCode>
                <c:ptCount val="6"/>
                <c:pt idx="0">
                  <c:v>0</c:v>
                </c:pt>
                <c:pt idx="1">
                  <c:v>0</c:v>
                </c:pt>
                <c:pt idx="2">
                  <c:v>3.4042553191539994E-3</c:v>
                </c:pt>
                <c:pt idx="3">
                  <c:v>0.11134751773</c:v>
                </c:pt>
                <c:pt idx="4">
                  <c:v>7.0212765957428005E-3</c:v>
                </c:pt>
                <c:pt idx="5">
                  <c:v>1.19680851063915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6D6-4A3E-A9D4-BA55A3055592}"/>
            </c:ext>
          </c:extLst>
        </c:ser>
        <c:ser>
          <c:idx val="1"/>
          <c:order val="1"/>
          <c:tx>
            <c:strRef>
              <c:f>'Summary 16S+SGM'!$A$3</c:f>
              <c:strCache>
                <c:ptCount val="1"/>
                <c:pt idx="0">
                  <c:v>SGM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'Summary 16S+SGM'!$B$1:$G$1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Summary 16S+SGM'!$B$3:$G$3</c:f>
              <c:numCache>
                <c:formatCode>0.00%</c:formatCode>
                <c:ptCount val="6"/>
                <c:pt idx="0">
                  <c:v>5.0062977174004488E-3</c:v>
                </c:pt>
                <c:pt idx="1">
                  <c:v>1.332729713345965E-2</c:v>
                </c:pt>
                <c:pt idx="2">
                  <c:v>1.2507064302289548E-2</c:v>
                </c:pt>
                <c:pt idx="3">
                  <c:v>0.1098763003277487</c:v>
                </c:pt>
                <c:pt idx="4">
                  <c:v>1.8080891505206233E-2</c:v>
                </c:pt>
                <c:pt idx="5">
                  <c:v>3.282188183887532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6D6-4A3E-A9D4-BA55A30555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93435504"/>
        <c:axId val="1093433536"/>
      </c:barChart>
      <c:catAx>
        <c:axId val="1093435504"/>
        <c:scaling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093433536"/>
        <c:crosses val="autoZero"/>
        <c:auto val="1"/>
        <c:lblAlgn val="ctr"/>
        <c:lblOffset val="100"/>
        <c:noMultiLvlLbl val="0"/>
      </c:catAx>
      <c:valAx>
        <c:axId val="1093433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Relative abundanc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he-IL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e-IL"/>
          </a:p>
        </c:txPr>
        <c:crossAx val="1093435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he-IL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1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Sphingobacteriia  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1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he-IL"/>
        </a:p>
      </c:txPr>
    </c:title>
    <c:autoTitleDeleted val="0"/>
    <c:plotArea>
      <c:layout>
        <c:manualLayout>
          <c:layoutTarget val="inner"/>
          <c:xMode val="edge"/>
          <c:yMode val="edge"/>
          <c:x val="0.18930666666666671"/>
          <c:y val="0.20222350427350427"/>
          <c:w val="0.77188777777777773"/>
          <c:h val="0.6474115384615384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16S+SGM'!$A$5</c:f>
              <c:strCache>
                <c:ptCount val="1"/>
                <c:pt idx="0">
                  <c:v>16S amplicon-seq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ummary 16S+SGM'!$B$1:$G$1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Summary 16S+SGM'!$B$5:$G$5</c:f>
              <c:numCache>
                <c:formatCode>0.00%</c:formatCode>
                <c:ptCount val="6"/>
                <c:pt idx="0">
                  <c:v>7.0921985815600001E-4</c:v>
                </c:pt>
                <c:pt idx="1">
                  <c:v>5.9101654846266665E-4</c:v>
                </c:pt>
                <c:pt idx="2">
                  <c:v>1.3333333333333201E-2</c:v>
                </c:pt>
                <c:pt idx="3">
                  <c:v>4.2553191489360003E-3</c:v>
                </c:pt>
                <c:pt idx="4">
                  <c:v>4.25531914893824E-2</c:v>
                </c:pt>
                <c:pt idx="5">
                  <c:v>4.10460992907649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99-4A49-8213-6266FA57A1D8}"/>
            </c:ext>
          </c:extLst>
        </c:ser>
        <c:ser>
          <c:idx val="1"/>
          <c:order val="1"/>
          <c:tx>
            <c:strRef>
              <c:f>'Summary 16S+SGM'!$A$6</c:f>
              <c:strCache>
                <c:ptCount val="1"/>
                <c:pt idx="0">
                  <c:v>SGM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'Summary 16S+SGM'!$B$1:$G$1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Summary 16S+SGM'!$B$6:$G$6</c:f>
              <c:numCache>
                <c:formatCode>0.00%</c:formatCode>
                <c:ptCount val="6"/>
                <c:pt idx="0">
                  <c:v>2.7813987684648989E-3</c:v>
                </c:pt>
                <c:pt idx="1">
                  <c:v>7.1567877975224113E-3</c:v>
                </c:pt>
                <c:pt idx="2">
                  <c:v>5.7726778400193487E-3</c:v>
                </c:pt>
                <c:pt idx="3">
                  <c:v>8.7439440610137427E-3</c:v>
                </c:pt>
                <c:pt idx="4">
                  <c:v>2.5203084725797482E-2</c:v>
                </c:pt>
                <c:pt idx="5">
                  <c:v>1.901676564803529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F99-4A49-8213-6266FA57A1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93435504"/>
        <c:axId val="1093433536"/>
      </c:barChart>
      <c:catAx>
        <c:axId val="1093435504"/>
        <c:scaling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1093433536"/>
        <c:crosses val="autoZero"/>
        <c:auto val="1"/>
        <c:lblAlgn val="ctr"/>
        <c:lblOffset val="100"/>
        <c:noMultiLvlLbl val="0"/>
      </c:catAx>
      <c:valAx>
        <c:axId val="1093433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Relative abundanc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he-IL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e-IL"/>
          </a:p>
        </c:txPr>
        <c:crossAx val="1093435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200">
          <a:latin typeface="Times New Roman" panose="02020603050405020304" pitchFamily="18" charset="0"/>
          <a:cs typeface="Times New Roman" panose="02020603050405020304" pitchFamily="18" charset="0"/>
        </a:defRPr>
      </a:pPr>
      <a:endParaRPr lang="he-IL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40" b="0" i="1" u="none" strike="noStrike" kern="1200" spc="0" baseline="0" dirty="0" err="1">
                <a:solidFill>
                  <a:prstClr val="black">
                    <a:lumMod val="65000"/>
                    <a:lumOff val="35000"/>
                  </a:prst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hizobiales</a:t>
            </a:r>
            <a:endParaRPr lang="en-US" sz="1440" b="0" i="1" u="none" strike="noStrike" kern="1200" spc="0" baseline="0" dirty="0">
              <a:solidFill>
                <a:prstClr val="black">
                  <a:lumMod val="65000"/>
                  <a:lumOff val="3500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he-IL"/>
        </a:p>
      </c:txPr>
    </c:title>
    <c:autoTitleDeleted val="0"/>
    <c:plotArea>
      <c:layout>
        <c:manualLayout>
          <c:layoutTarget val="inner"/>
          <c:xMode val="edge"/>
          <c:yMode val="edge"/>
          <c:x val="0.2134483333333333"/>
          <c:y val="0.20189786324786324"/>
          <c:w val="0.74774611111111111"/>
          <c:h val="0.5720799145299145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16S+SGM'!$A$24</c:f>
              <c:strCache>
                <c:ptCount val="1"/>
                <c:pt idx="0">
                  <c:v>16S amplicon-seq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ummary 16S+SGM'!$B$1:$G$1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Summary 16S+SGM'!$B$24:$G$24</c:f>
              <c:numCache>
                <c:formatCode>0.00%</c:formatCode>
                <c:ptCount val="6"/>
                <c:pt idx="0">
                  <c:v>0</c:v>
                </c:pt>
                <c:pt idx="1">
                  <c:v>0</c:v>
                </c:pt>
                <c:pt idx="2">
                  <c:v>4.964539007096E-4</c:v>
                </c:pt>
                <c:pt idx="3">
                  <c:v>1.06382978723E-3</c:v>
                </c:pt>
                <c:pt idx="4">
                  <c:v>9.4326241134719997E-3</c:v>
                </c:pt>
                <c:pt idx="5">
                  <c:v>1.1081560283687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01A-40B3-8ABF-DCFF8FAC208E}"/>
            </c:ext>
          </c:extLst>
        </c:ser>
        <c:ser>
          <c:idx val="1"/>
          <c:order val="1"/>
          <c:tx>
            <c:strRef>
              <c:f>'Summary 16S+SGM'!$A$25</c:f>
              <c:strCache>
                <c:ptCount val="1"/>
                <c:pt idx="0">
                  <c:v>SGM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ummary 16S+SGM'!$B$1:$G$1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Summary 16S+SGM'!$B$25:$G$25</c:f>
              <c:numCache>
                <c:formatCode>0.00%</c:formatCode>
                <c:ptCount val="6"/>
                <c:pt idx="0">
                  <c:v>2.5948096138761483E-3</c:v>
                </c:pt>
                <c:pt idx="1">
                  <c:v>2.2702910340896597E-3</c:v>
                </c:pt>
                <c:pt idx="2">
                  <c:v>1.9624429007167208E-3</c:v>
                </c:pt>
                <c:pt idx="3">
                  <c:v>3.2045278825911521E-3</c:v>
                </c:pt>
                <c:pt idx="4">
                  <c:v>1.5843892681264526E-2</c:v>
                </c:pt>
                <c:pt idx="5">
                  <c:v>9.825514727436559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01A-40B3-8ABF-DCFF8FAC20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93435504"/>
        <c:axId val="1093433536"/>
      </c:barChart>
      <c:catAx>
        <c:axId val="1093435504"/>
        <c:scaling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crossAx val="1093433536"/>
        <c:crosses val="autoZero"/>
        <c:auto val="1"/>
        <c:lblAlgn val="ctr"/>
        <c:lblOffset val="100"/>
        <c:noMultiLvlLbl val="0"/>
      </c:catAx>
      <c:valAx>
        <c:axId val="1093433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abundanc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he-IL"/>
            </a:p>
          </c:txPr>
        </c:title>
        <c:numFmt formatCode="0.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he-IL"/>
          </a:p>
        </c:txPr>
        <c:crossAx val="1093435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200"/>
      </a:pPr>
      <a:endParaRPr lang="he-IL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40" b="0" i="1" u="none" strike="noStrike" kern="1200" spc="0" baseline="0" dirty="0" err="1">
                <a:solidFill>
                  <a:prstClr val="black">
                    <a:lumMod val="65000"/>
                    <a:lumOff val="35000"/>
                  </a:prst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choleplasmatales</a:t>
            </a:r>
            <a:endParaRPr lang="en-US" sz="1440" b="0" i="1" u="none" strike="noStrike" kern="1200" spc="0" baseline="0" dirty="0">
              <a:solidFill>
                <a:prstClr val="black">
                  <a:lumMod val="65000"/>
                  <a:lumOff val="35000"/>
                </a:prst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he-IL"/>
        </a:p>
      </c:txPr>
    </c:title>
    <c:autoTitleDeleted val="0"/>
    <c:plotArea>
      <c:layout>
        <c:manualLayout>
          <c:layoutTarget val="inner"/>
          <c:xMode val="edge"/>
          <c:yMode val="edge"/>
          <c:x val="0.20682805555555556"/>
          <c:y val="0.20558846153846153"/>
          <c:w val="0.7296719444444445"/>
          <c:h val="0.602690170940170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16S+SGM'!$A$28</c:f>
              <c:strCache>
                <c:ptCount val="1"/>
                <c:pt idx="0">
                  <c:v>16S amplicon-seq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ummary 16S+SGM'!$B$1:$G$1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Summary 16S+SGM'!$B$28:$G$28</c:f>
              <c:numCache>
                <c:formatCode>0.00%</c:formatCode>
                <c:ptCount val="6"/>
                <c:pt idx="0">
                  <c:v>0</c:v>
                </c:pt>
                <c:pt idx="1">
                  <c:v>1.1820330969266667E-4</c:v>
                </c:pt>
                <c:pt idx="2">
                  <c:v>7.6595744680859985E-3</c:v>
                </c:pt>
                <c:pt idx="3">
                  <c:v>9.2198581560300006E-3</c:v>
                </c:pt>
                <c:pt idx="4">
                  <c:v>5.5319148936192001E-3</c:v>
                </c:pt>
                <c:pt idx="5">
                  <c:v>2.7127659574475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203-4173-9E36-393450B82F45}"/>
            </c:ext>
          </c:extLst>
        </c:ser>
        <c:ser>
          <c:idx val="1"/>
          <c:order val="1"/>
          <c:tx>
            <c:strRef>
              <c:f>'Summary 16S+SGM'!$A$29</c:f>
              <c:strCache>
                <c:ptCount val="1"/>
                <c:pt idx="0">
                  <c:v>SGM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Summary 16S+SGM'!$B$1:$G$1</c:f>
              <c:strCache>
                <c:ptCount val="6"/>
                <c:pt idx="0">
                  <c:v>EDC</c:v>
                </c:pt>
                <c:pt idx="1">
                  <c:v>EDC+B</c:v>
                </c:pt>
                <c:pt idx="2">
                  <c:v>EDC+FWW</c:v>
                </c:pt>
                <c:pt idx="3">
                  <c:v>EDC+B--WW</c:v>
                </c:pt>
                <c:pt idx="4">
                  <c:v>EDC+WW</c:v>
                </c:pt>
                <c:pt idx="5">
                  <c:v>WW</c:v>
                </c:pt>
              </c:strCache>
            </c:strRef>
          </c:cat>
          <c:val>
            <c:numRef>
              <c:f>'Summary 16S+SGM'!$B$29:$G$29</c:f>
              <c:numCache>
                <c:formatCode>0.00%</c:formatCode>
                <c:ptCount val="6"/>
                <c:pt idx="0">
                  <c:v>3.5377250360732888E-5</c:v>
                </c:pt>
                <c:pt idx="1">
                  <c:v>8.0045470791469581E-5</c:v>
                </c:pt>
                <c:pt idx="2">
                  <c:v>2.8506751542501183E-3</c:v>
                </c:pt>
                <c:pt idx="3">
                  <c:v>5.4286540218541363E-3</c:v>
                </c:pt>
                <c:pt idx="4">
                  <c:v>7.5556255725195481E-3</c:v>
                </c:pt>
                <c:pt idx="5">
                  <c:v>3.17912302415904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203-4173-9E36-393450B82F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93435504"/>
        <c:axId val="1093433536"/>
      </c:barChart>
      <c:catAx>
        <c:axId val="1093435504"/>
        <c:scaling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crossAx val="1093433536"/>
        <c:crosses val="autoZero"/>
        <c:auto val="1"/>
        <c:lblAlgn val="ctr"/>
        <c:lblOffset val="100"/>
        <c:noMultiLvlLbl val="0"/>
      </c:catAx>
      <c:valAx>
        <c:axId val="1093433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elative abundanc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10934355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200"/>
      </a:pPr>
      <a:endParaRPr lang="he-I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826438"/>
            <a:ext cx="10363200" cy="388537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861650"/>
            <a:ext cx="9144000" cy="2694446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EF773-BA7D-443D-AB8D-1C88C4114D5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4C4B8-FB3C-42F5-BD4F-29A11C1609F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63760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EF773-BA7D-443D-AB8D-1C88C4114D5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4C4B8-FB3C-42F5-BD4F-29A11C1609F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14691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594173"/>
            <a:ext cx="2628900" cy="945769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594173"/>
            <a:ext cx="7734300" cy="945769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EF773-BA7D-443D-AB8D-1C88C4114D5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4C4B8-FB3C-42F5-BD4F-29A11C1609F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30705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EF773-BA7D-443D-AB8D-1C88C4114D5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4C4B8-FB3C-42F5-BD4F-29A11C1609F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58214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782285"/>
            <a:ext cx="10515600" cy="4642301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7468503"/>
            <a:ext cx="10515600" cy="2441277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EF773-BA7D-443D-AB8D-1C88C4114D5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4C4B8-FB3C-42F5-BD4F-29A11C1609F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19343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970867"/>
            <a:ext cx="5181600" cy="7080997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970867"/>
            <a:ext cx="5181600" cy="7080997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EF773-BA7D-443D-AB8D-1C88C4114D5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4C4B8-FB3C-42F5-BD4F-29A11C1609F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17687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4176"/>
            <a:ext cx="10515600" cy="215710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735782"/>
            <a:ext cx="5157787" cy="134076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076545"/>
            <a:ext cx="5157787" cy="599598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735782"/>
            <a:ext cx="5183188" cy="134076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076545"/>
            <a:ext cx="5183188" cy="599598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EF773-BA7D-443D-AB8D-1C88C4114D5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4C4B8-FB3C-42F5-BD4F-29A11C1609F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23816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EF773-BA7D-443D-AB8D-1C88C4114D5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4C4B8-FB3C-42F5-BD4F-29A11C1609F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65146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EF773-BA7D-443D-AB8D-1C88C4114D5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4C4B8-FB3C-42F5-BD4F-29A11C1609F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588435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44008"/>
            <a:ext cx="3932237" cy="260402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606854"/>
            <a:ext cx="6172200" cy="7930922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348037"/>
            <a:ext cx="3932237" cy="6202654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EF773-BA7D-443D-AB8D-1C88C4114D5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4C4B8-FB3C-42F5-BD4F-29A11C1609F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40193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44008"/>
            <a:ext cx="3932237" cy="2604029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606854"/>
            <a:ext cx="6172200" cy="7930922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348037"/>
            <a:ext cx="3932237" cy="6202654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5EF773-BA7D-443D-AB8D-1C88C4114D5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F4C4B8-FB3C-42F5-BD4F-29A11C1609F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09763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594176"/>
            <a:ext cx="10515600" cy="21571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970867"/>
            <a:ext cx="10515600" cy="708099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0343785"/>
            <a:ext cx="2743200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5EF773-BA7D-443D-AB8D-1C88C4114D5D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0343785"/>
            <a:ext cx="4114800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0343785"/>
            <a:ext cx="2743200" cy="5941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F4C4B8-FB3C-42F5-BD4F-29A11C1609F1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96571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1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r" defTabSz="1219170" rtl="1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r" defTabSz="1219170" rtl="1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r" defTabSz="1219170" rtl="1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r" defTabSz="1219170" rtl="1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r" defTabSz="1219170" rtl="1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r" defTabSz="1219170" rtl="1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r" defTabSz="1219170" rtl="1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r" defTabSz="1219170" rtl="1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r" defTabSz="1219170" rtl="1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1219170" rtl="1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r" defTabSz="1219170" rtl="1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r" defTabSz="1219170" rtl="1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r" defTabSz="1219170" rtl="1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r" defTabSz="1219170" rtl="1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r" defTabSz="1219170" rtl="1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r" defTabSz="1219170" rtl="1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r" defTabSz="1219170" rtl="1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r" defTabSz="1219170" rtl="1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2" name="Group 71"/>
          <p:cNvGrpSpPr/>
          <p:nvPr/>
        </p:nvGrpSpPr>
        <p:grpSpPr>
          <a:xfrm>
            <a:off x="2433690" y="151726"/>
            <a:ext cx="7324620" cy="10338513"/>
            <a:chOff x="7172747" y="1528852"/>
            <a:chExt cx="7324620" cy="10338513"/>
          </a:xfrm>
        </p:grpSpPr>
        <p:graphicFrame>
          <p:nvGraphicFramePr>
            <p:cNvPr id="73" name="Chart 7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12475201"/>
                </p:ext>
              </p:extLst>
            </p:nvPr>
          </p:nvGraphicFramePr>
          <p:xfrm>
            <a:off x="10897367" y="2225409"/>
            <a:ext cx="3600000" cy="23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74" name="Chart 7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35143762"/>
                </p:ext>
              </p:extLst>
            </p:nvPr>
          </p:nvGraphicFramePr>
          <p:xfrm>
            <a:off x="7175113" y="2225409"/>
            <a:ext cx="3600000" cy="23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75" name="Chart 7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90496151"/>
                </p:ext>
              </p:extLst>
            </p:nvPr>
          </p:nvGraphicFramePr>
          <p:xfrm>
            <a:off x="7175113" y="4667009"/>
            <a:ext cx="3600000" cy="23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6" name="Chart 7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01816146"/>
                </p:ext>
              </p:extLst>
            </p:nvPr>
          </p:nvGraphicFramePr>
          <p:xfrm>
            <a:off x="10897367" y="4667009"/>
            <a:ext cx="3600000" cy="23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pSp>
          <p:nvGrpSpPr>
            <p:cNvPr id="77" name="Group 76"/>
            <p:cNvGrpSpPr/>
            <p:nvPr/>
          </p:nvGrpSpPr>
          <p:grpSpPr>
            <a:xfrm>
              <a:off x="7898041" y="6542675"/>
              <a:ext cx="2691551" cy="441490"/>
              <a:chOff x="7152799" y="4337593"/>
              <a:chExt cx="2691551" cy="441490"/>
            </a:xfrm>
          </p:grpSpPr>
          <p:sp>
            <p:nvSpPr>
              <p:cNvPr id="134" name="TextBox 133"/>
              <p:cNvSpPr txBox="1"/>
              <p:nvPr/>
            </p:nvSpPr>
            <p:spPr>
              <a:xfrm>
                <a:off x="7152799" y="4432834"/>
                <a:ext cx="484428" cy="2616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TextBox 134"/>
              <p:cNvSpPr txBox="1"/>
              <p:nvPr/>
            </p:nvSpPr>
            <p:spPr>
              <a:xfrm>
                <a:off x="7559799" y="4348196"/>
                <a:ext cx="484428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B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TextBox 135"/>
              <p:cNvSpPr txBox="1"/>
              <p:nvPr/>
            </p:nvSpPr>
            <p:spPr>
              <a:xfrm>
                <a:off x="7849464" y="4337593"/>
                <a:ext cx="619080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F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TextBox 136"/>
              <p:cNvSpPr txBox="1"/>
              <p:nvPr/>
            </p:nvSpPr>
            <p:spPr>
              <a:xfrm>
                <a:off x="8429430" y="4348196"/>
                <a:ext cx="660757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+B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-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" name="TextBox 137"/>
              <p:cNvSpPr txBox="1"/>
              <p:nvPr/>
            </p:nvSpPr>
            <p:spPr>
              <a:xfrm>
                <a:off x="8898894" y="4348196"/>
                <a:ext cx="627095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E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" name="TextBox 138"/>
              <p:cNvSpPr txBox="1"/>
              <p:nvPr/>
            </p:nvSpPr>
            <p:spPr>
              <a:xfrm>
                <a:off x="9393585" y="4432834"/>
                <a:ext cx="450765" cy="2616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8" name="Group 77"/>
            <p:cNvGrpSpPr/>
            <p:nvPr/>
          </p:nvGrpSpPr>
          <p:grpSpPr>
            <a:xfrm>
              <a:off x="11580264" y="6553278"/>
              <a:ext cx="2691551" cy="430887"/>
              <a:chOff x="7152799" y="4348196"/>
              <a:chExt cx="2691551" cy="430887"/>
            </a:xfrm>
          </p:grpSpPr>
          <p:sp>
            <p:nvSpPr>
              <p:cNvPr id="128" name="TextBox 127"/>
              <p:cNvSpPr txBox="1"/>
              <p:nvPr/>
            </p:nvSpPr>
            <p:spPr>
              <a:xfrm>
                <a:off x="7152799" y="4432834"/>
                <a:ext cx="484428" cy="2616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" name="TextBox 128"/>
              <p:cNvSpPr txBox="1"/>
              <p:nvPr/>
            </p:nvSpPr>
            <p:spPr>
              <a:xfrm>
                <a:off x="7559799" y="4348196"/>
                <a:ext cx="484428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B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TextBox 129"/>
              <p:cNvSpPr txBox="1"/>
              <p:nvPr/>
            </p:nvSpPr>
            <p:spPr>
              <a:xfrm>
                <a:off x="7945002" y="4348196"/>
                <a:ext cx="619080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F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>
                <a:off x="8429430" y="4348196"/>
                <a:ext cx="660757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+B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-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8898894" y="4348196"/>
                <a:ext cx="627095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E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>
                <a:off x="9393585" y="4432834"/>
                <a:ext cx="450765" cy="2616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9" name="Rectangle 78"/>
            <p:cNvSpPr/>
            <p:nvPr/>
          </p:nvSpPr>
          <p:spPr>
            <a:xfrm>
              <a:off x="9789148" y="1569657"/>
              <a:ext cx="180000" cy="180000"/>
            </a:xfrm>
            <a:prstGeom prst="rec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9969148" y="1528852"/>
              <a:ext cx="1750800" cy="261610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S Amplicon Sequencing</a:t>
              </a:r>
              <a:endParaRPr lang="he-IL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Rectangle 80"/>
            <p:cNvSpPr/>
            <p:nvPr/>
          </p:nvSpPr>
          <p:spPr>
            <a:xfrm>
              <a:off x="9789148" y="1831267"/>
              <a:ext cx="180000" cy="180000"/>
            </a:xfrm>
            <a:prstGeom prst="rect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9969148" y="1790462"/>
              <a:ext cx="1572866" cy="261610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tgun metagenomics</a:t>
              </a:r>
              <a:endParaRPr lang="he-IL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3" name="Group 82"/>
            <p:cNvGrpSpPr/>
            <p:nvPr/>
          </p:nvGrpSpPr>
          <p:grpSpPr>
            <a:xfrm>
              <a:off x="7935432" y="4151058"/>
              <a:ext cx="2691551" cy="441490"/>
              <a:chOff x="7152799" y="4337593"/>
              <a:chExt cx="2691551" cy="441490"/>
            </a:xfrm>
          </p:grpSpPr>
          <p:sp>
            <p:nvSpPr>
              <p:cNvPr id="122" name="TextBox 121"/>
              <p:cNvSpPr txBox="1"/>
              <p:nvPr/>
            </p:nvSpPr>
            <p:spPr>
              <a:xfrm>
                <a:off x="7152799" y="4432834"/>
                <a:ext cx="484428" cy="2616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7559799" y="4348196"/>
                <a:ext cx="484428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B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" name="TextBox 123"/>
              <p:cNvSpPr txBox="1"/>
              <p:nvPr/>
            </p:nvSpPr>
            <p:spPr>
              <a:xfrm>
                <a:off x="7849464" y="4337593"/>
                <a:ext cx="619080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F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" name="TextBox 124"/>
              <p:cNvSpPr txBox="1"/>
              <p:nvPr/>
            </p:nvSpPr>
            <p:spPr>
              <a:xfrm>
                <a:off x="8429430" y="4348196"/>
                <a:ext cx="660757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+B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-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TextBox 125"/>
              <p:cNvSpPr txBox="1"/>
              <p:nvPr/>
            </p:nvSpPr>
            <p:spPr>
              <a:xfrm>
                <a:off x="8898894" y="4348196"/>
                <a:ext cx="627095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E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>
                <a:off x="9393585" y="4432834"/>
                <a:ext cx="450765" cy="2616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4" name="Group 83"/>
            <p:cNvGrpSpPr/>
            <p:nvPr/>
          </p:nvGrpSpPr>
          <p:grpSpPr>
            <a:xfrm>
              <a:off x="11580264" y="4151058"/>
              <a:ext cx="2691551" cy="430887"/>
              <a:chOff x="7152799" y="4348196"/>
              <a:chExt cx="2691551" cy="430887"/>
            </a:xfrm>
          </p:grpSpPr>
          <p:sp>
            <p:nvSpPr>
              <p:cNvPr id="116" name="TextBox 115"/>
              <p:cNvSpPr txBox="1"/>
              <p:nvPr/>
            </p:nvSpPr>
            <p:spPr>
              <a:xfrm>
                <a:off x="7152799" y="4432834"/>
                <a:ext cx="484428" cy="2616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>
                <a:off x="7559799" y="4348196"/>
                <a:ext cx="484428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B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" name="TextBox 117"/>
              <p:cNvSpPr txBox="1"/>
              <p:nvPr/>
            </p:nvSpPr>
            <p:spPr>
              <a:xfrm>
                <a:off x="7945002" y="4348196"/>
                <a:ext cx="619080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F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8429430" y="4348196"/>
                <a:ext cx="660757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+B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-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8898894" y="4348196"/>
                <a:ext cx="627095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E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9393585" y="4432834"/>
                <a:ext cx="450765" cy="2616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aphicFrame>
          <p:nvGraphicFramePr>
            <p:cNvPr id="85" name="Chart 8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33927976"/>
                </p:ext>
              </p:extLst>
            </p:nvPr>
          </p:nvGraphicFramePr>
          <p:xfrm>
            <a:off x="7176096" y="7108609"/>
            <a:ext cx="3600000" cy="23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86" name="Chart 8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47997291"/>
                </p:ext>
              </p:extLst>
            </p:nvPr>
          </p:nvGraphicFramePr>
          <p:xfrm>
            <a:off x="10897367" y="7108609"/>
            <a:ext cx="3600000" cy="23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pSp>
          <p:nvGrpSpPr>
            <p:cNvPr id="87" name="Group 86"/>
            <p:cNvGrpSpPr/>
            <p:nvPr/>
          </p:nvGrpSpPr>
          <p:grpSpPr>
            <a:xfrm>
              <a:off x="11580264" y="9073498"/>
              <a:ext cx="2691551" cy="430887"/>
              <a:chOff x="7152799" y="4348196"/>
              <a:chExt cx="2691551" cy="430887"/>
            </a:xfrm>
          </p:grpSpPr>
          <p:sp>
            <p:nvSpPr>
              <p:cNvPr id="110" name="TextBox 109"/>
              <p:cNvSpPr txBox="1"/>
              <p:nvPr/>
            </p:nvSpPr>
            <p:spPr>
              <a:xfrm>
                <a:off x="7152799" y="4432834"/>
                <a:ext cx="484428" cy="2616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7559799" y="4348196"/>
                <a:ext cx="484428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B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2" name="TextBox 111"/>
              <p:cNvSpPr txBox="1"/>
              <p:nvPr/>
            </p:nvSpPr>
            <p:spPr>
              <a:xfrm>
                <a:off x="7945002" y="4348196"/>
                <a:ext cx="619080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F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" name="TextBox 112"/>
              <p:cNvSpPr txBox="1"/>
              <p:nvPr/>
            </p:nvSpPr>
            <p:spPr>
              <a:xfrm>
                <a:off x="8429430" y="4348196"/>
                <a:ext cx="660757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+B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-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4" name="TextBox 113"/>
              <p:cNvSpPr txBox="1"/>
              <p:nvPr/>
            </p:nvSpPr>
            <p:spPr>
              <a:xfrm>
                <a:off x="8898894" y="4348196"/>
                <a:ext cx="627095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E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>
                <a:off x="9393585" y="4432834"/>
                <a:ext cx="450765" cy="2616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8" name="Group 87"/>
            <p:cNvGrpSpPr/>
            <p:nvPr/>
          </p:nvGrpSpPr>
          <p:grpSpPr>
            <a:xfrm>
              <a:off x="7935432" y="8993950"/>
              <a:ext cx="2691551" cy="430887"/>
              <a:chOff x="7152799" y="4348196"/>
              <a:chExt cx="2691551" cy="430887"/>
            </a:xfrm>
          </p:grpSpPr>
          <p:sp>
            <p:nvSpPr>
              <p:cNvPr id="104" name="TextBox 103"/>
              <p:cNvSpPr txBox="1"/>
              <p:nvPr/>
            </p:nvSpPr>
            <p:spPr>
              <a:xfrm>
                <a:off x="7152799" y="4432834"/>
                <a:ext cx="484428" cy="2616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>
                <a:off x="7559799" y="4348196"/>
                <a:ext cx="484428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B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7945002" y="4348196"/>
                <a:ext cx="619080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F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8429430" y="4348196"/>
                <a:ext cx="660757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+B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-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8" name="TextBox 107"/>
              <p:cNvSpPr txBox="1"/>
              <p:nvPr/>
            </p:nvSpPr>
            <p:spPr>
              <a:xfrm>
                <a:off x="8898894" y="4348196"/>
                <a:ext cx="627095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E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TextBox 108"/>
              <p:cNvSpPr txBox="1"/>
              <p:nvPr/>
            </p:nvSpPr>
            <p:spPr>
              <a:xfrm>
                <a:off x="9393585" y="4432834"/>
                <a:ext cx="450765" cy="2616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aphicFrame>
          <p:nvGraphicFramePr>
            <p:cNvPr id="89" name="Chart 8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5834614"/>
                </p:ext>
              </p:extLst>
            </p:nvPr>
          </p:nvGraphicFramePr>
          <p:xfrm>
            <a:off x="7172747" y="9527365"/>
            <a:ext cx="3600000" cy="23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90" name="TextBox 89"/>
            <p:cNvSpPr txBox="1"/>
            <p:nvPr/>
          </p:nvSpPr>
          <p:spPr>
            <a:xfrm>
              <a:off x="8011632" y="11501748"/>
              <a:ext cx="484428" cy="261610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pPr algn="ctr"/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DC</a:t>
              </a:r>
              <a:endParaRPr lang="he-IL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8418632" y="11417110"/>
              <a:ext cx="484428" cy="430887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pPr algn="ctr"/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DC</a:t>
              </a:r>
            </a:p>
            <a:p>
              <a:pPr algn="ctr"/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B</a:t>
              </a:r>
              <a:endParaRPr lang="he-IL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9288263" y="11417110"/>
              <a:ext cx="660757" cy="430887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pPr algn="ctr"/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DC+B</a:t>
              </a:r>
            </a:p>
            <a:p>
              <a:pPr algn="ctr"/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-WW</a:t>
              </a:r>
              <a:endParaRPr lang="he-IL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9757727" y="11417110"/>
              <a:ext cx="627095" cy="430887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pPr algn="ctr"/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DC</a:t>
              </a:r>
            </a:p>
            <a:p>
              <a:pPr algn="ctr"/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EWW</a:t>
              </a:r>
              <a:endParaRPr lang="he-IL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10252418" y="11501748"/>
              <a:ext cx="450765" cy="261610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pPr algn="ctr"/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W</a:t>
              </a:r>
              <a:endParaRPr lang="he-IL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8803595" y="11397742"/>
              <a:ext cx="619080" cy="430887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pPr algn="ctr"/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DC</a:t>
              </a:r>
            </a:p>
            <a:p>
              <a:pPr algn="ctr"/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FWW</a:t>
              </a:r>
              <a:endParaRPr lang="he-IL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96" name="Chart 9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29176496"/>
                </p:ext>
              </p:extLst>
            </p:nvPr>
          </p:nvGraphicFramePr>
          <p:xfrm>
            <a:off x="10896486" y="9527365"/>
            <a:ext cx="3600000" cy="23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pSp>
          <p:nvGrpSpPr>
            <p:cNvPr id="97" name="Group 96"/>
            <p:cNvGrpSpPr/>
            <p:nvPr/>
          </p:nvGrpSpPr>
          <p:grpSpPr>
            <a:xfrm>
              <a:off x="11580264" y="11417110"/>
              <a:ext cx="2691551" cy="430887"/>
              <a:chOff x="7152799" y="4348196"/>
              <a:chExt cx="2691551" cy="430887"/>
            </a:xfrm>
          </p:grpSpPr>
          <p:sp>
            <p:nvSpPr>
              <p:cNvPr id="98" name="TextBox 97"/>
              <p:cNvSpPr txBox="1"/>
              <p:nvPr/>
            </p:nvSpPr>
            <p:spPr>
              <a:xfrm>
                <a:off x="7152799" y="4432834"/>
                <a:ext cx="484428" cy="2616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7559799" y="4348196"/>
                <a:ext cx="484428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B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7945002" y="4348196"/>
                <a:ext cx="619080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F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8429430" y="4348196"/>
                <a:ext cx="660757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+B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-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8898894" y="4348196"/>
                <a:ext cx="627095" cy="430887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DC</a:t>
                </a:r>
              </a:p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E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9393585" y="4432834"/>
                <a:ext cx="450765" cy="261610"/>
              </a:xfrm>
              <a:prstGeom prst="rect">
                <a:avLst/>
              </a:prstGeom>
              <a:noFill/>
            </p:spPr>
            <p:txBody>
              <a:bodyPr wrap="none" rtlCol="1">
                <a:spAutoFit/>
              </a:bodyPr>
              <a:lstStyle/>
              <a:p>
                <a:pPr algn="ctr"/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W</a:t>
                </a:r>
                <a:endParaRPr lang="he-IL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40" name="Rectangle 139">
            <a:extLst>
              <a:ext uri="{FF2B5EF4-FFF2-40B4-BE49-F238E27FC236}">
                <a16:creationId xmlns:a16="http://schemas.microsoft.com/office/drawing/2014/main" id="{A68674D5-B58D-430F-9794-3879C9A23210}"/>
              </a:ext>
            </a:extLst>
          </p:cNvPr>
          <p:cNvSpPr/>
          <p:nvPr/>
        </p:nvSpPr>
        <p:spPr>
          <a:xfrm>
            <a:off x="0" y="10821571"/>
            <a:ext cx="1149927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</a:rPr>
              <a:t>Figure </a:t>
            </a:r>
            <a:r>
              <a:rPr lang="en-US" sz="1600" b="1" dirty="0" smtClean="0">
                <a:latin typeface="Times New Roman" panose="02020603050405020304" pitchFamily="18" charset="0"/>
              </a:rPr>
              <a:t>S10: </a:t>
            </a:r>
            <a:r>
              <a:rPr lang="en-US" sz="1600" dirty="0" smtClean="0">
                <a:latin typeface="Times New Roman" panose="02020603050405020304" pitchFamily="18" charset="0"/>
              </a:rPr>
              <a:t>Relative abundance of key t</a:t>
            </a:r>
            <a:r>
              <a:rPr lang="en-US" sz="1600" dirty="0" smtClean="0">
                <a:latin typeface="Times New Roman" panose="02020603050405020304" pitchFamily="18" charset="0"/>
              </a:rPr>
              <a:t>axonomic </a:t>
            </a:r>
            <a:r>
              <a:rPr lang="en-US" sz="1600" dirty="0">
                <a:latin typeface="Times New Roman" panose="02020603050405020304" pitchFamily="18" charset="0"/>
              </a:rPr>
              <a:t>groups according </a:t>
            </a:r>
            <a:r>
              <a:rPr lang="en-US" sz="1600" dirty="0" smtClean="0">
                <a:latin typeface="Times New Roman" panose="02020603050405020304" pitchFamily="18" charset="0"/>
              </a:rPr>
              <a:t>to16S </a:t>
            </a:r>
            <a:r>
              <a:rPr lang="en-US" sz="1600" dirty="0" err="1">
                <a:latin typeface="Times New Roman" panose="02020603050405020304" pitchFamily="18" charset="0"/>
              </a:rPr>
              <a:t>rRNA</a:t>
            </a:r>
            <a:r>
              <a:rPr lang="en-US" sz="1600" dirty="0">
                <a:latin typeface="Times New Roman" panose="02020603050405020304" pitchFamily="18" charset="0"/>
              </a:rPr>
              <a:t> gene amplicon and shotgun </a:t>
            </a:r>
            <a:r>
              <a:rPr lang="en-US" sz="1600" dirty="0" err="1">
                <a:latin typeface="Times New Roman" panose="02020603050405020304" pitchFamily="18" charset="0"/>
              </a:rPr>
              <a:t>metagenomic</a:t>
            </a:r>
            <a:r>
              <a:rPr lang="en-US" sz="1600" dirty="0">
                <a:latin typeface="Times New Roman" panose="02020603050405020304" pitchFamily="18" charset="0"/>
              </a:rPr>
              <a:t> sequencing   </a:t>
            </a:r>
            <a:endParaRPr lang="he-IL" sz="1600" dirty="0"/>
          </a:p>
        </p:txBody>
      </p:sp>
    </p:spTree>
    <p:extLst>
      <p:ext uri="{BB962C8B-B14F-4D97-AF65-F5344CB8AC3E}">
        <p14:creationId xmlns:p14="http://schemas.microsoft.com/office/powerpoint/2010/main" val="40116902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59</Words>
  <Application>Microsoft Office PowerPoint</Application>
  <PresentationFormat>Custom</PresentationFormat>
  <Paragraphs>9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Volcan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ren Yanuka-Golub</dc:creator>
  <cp:lastModifiedBy>Keren Yanuka-Golub</cp:lastModifiedBy>
  <cp:revision>2</cp:revision>
  <dcterms:created xsi:type="dcterms:W3CDTF">2020-02-16T13:44:38Z</dcterms:created>
  <dcterms:modified xsi:type="dcterms:W3CDTF">2020-02-16T13:48:23Z</dcterms:modified>
</cp:coreProperties>
</file>